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7C49B-3C88-4C4F-A6A2-98C1EAFC2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F9463F-160F-4D86-B374-3C75223F89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3C7B4A-9025-4E2C-BD4F-3A3952CF9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95F3D4-3B4B-4B7D-8247-FA7BC31A4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4A61F0-ECFF-4B6B-B9B2-A1A503830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8904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A9A6A-B07B-4877-9ADF-8DEA50064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52D5F6-48D1-41DE-986C-2AF8DFC6CE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6BA9E5-9A43-41B8-AA59-9857447D3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41B7FB-84E1-4A48-A5A6-33FD7A84C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BB561-26EB-4E76-BEDB-C56D64AF3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593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235857-6BAD-4421-B85F-8C65DDB38C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305943-13D6-4AD9-BBB4-B355B5E1A1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2CE34-6D75-4231-BD37-66C78D706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9C364-1A50-4F4E-A2B7-7672AE498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7B508B-93DF-4D44-AE3C-DF684B98F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23032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9A1E1F-8C98-4EC8-B8AF-3E17FA4DB5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E3CC4D-C0B7-4C0F-90F0-58DE11DBA9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C18D2-5A6F-4E85-99AB-358139DC3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E2685-2F9B-4644-B5B3-7151114CB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3CA41-E8B0-4E6E-9279-91F85D6EB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23002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EE950A-16E6-405F-A16A-C5455EB0FA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2AEA48-9A3E-41D1-BE56-2A4FA9D0C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FF53D5-88B8-4AEB-9323-8A0386D34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F6C68A-2964-400A-8FC5-EDAE8A25D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349C84-3B67-4309-AE48-08E201D60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4986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05B9C-A956-43EB-901E-E5B91CFBEE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9164FF-C0F4-41FF-999F-9B123B9D14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8A6780-60D5-4276-B6C7-4FEFF3B269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C6AE23-FAB4-40CB-8711-D0D60DB44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9C8285-6B5E-47CC-9DB7-AA31E9E2B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F69AF2-72FC-436D-9005-F6E312BAB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77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3F89AD-EA9F-4C2D-9B02-C2BEFC201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18409F-B767-4882-98F8-A5C8B25C92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82B2FD-BAD7-4167-9CC1-A0A856DF9E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EB5EA2-C558-45DE-8AB2-42D091CD1D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5C02E3-F64E-4806-8C13-FC00982493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B44F6E-5F32-4255-B263-2482A6E31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0AD1A7-DB38-4370-AF75-B1937B878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0732EA-7682-4147-8B0F-0C04E32BB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1324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0E4DBD-2579-4B01-8FE5-5EF0BDBA42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D00F91-E981-424E-90A7-E06BF1084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095706-B479-49F8-A9DB-366EE2EAF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DF4599-67E3-4B4D-8C46-4B02C2BAC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80796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D3FE7E-C7DA-427C-B3A9-C9BB7EF98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1A7D62-9130-4F69-B80F-487BEE171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17D829-5BEF-4A19-9A52-80B80FB1C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48124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7F81F-A26D-4300-86A0-B549A8B8F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852271-B2DC-467A-86B2-A0E717E54B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8E6E98-DFEB-4916-A7AA-B9873EE0EC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8F2972-F401-4B76-9AD5-C7211B979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6319E1-B266-4E86-BC1C-180CA9BA3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0AD2F4-856F-4EF4-A457-45CFAEF1E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49973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1C76C3-54B2-4F6A-B69F-6D63D17933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F95A92-87BC-4E00-88F6-BC72CA67D3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ABA255-D67E-461E-ABD9-691839539E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91C285-AABD-4E3D-B477-DD9BD0154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4E8B18-0C7C-4DF7-BD58-6F838EB68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2A21D4-C20E-46BE-B55B-371247BF0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33557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9ED1C2-E850-407C-B658-B1B9D42C7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971807-6C44-4827-A79F-70D72CFB9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2D82C-A76E-402B-A22B-BDBFA95BA0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A67BA-91F1-45BB-9603-830700D335A9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8E4891-42ED-414F-A9CD-5BF98F3EEE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831B6A-B7DB-4882-A892-8312701517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82283-E01E-48F5-82B1-B4612A3DBF0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00427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microreact.org/project/85VRSrPfG8iQhLJhUzYHuA/56a61920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DD778AE-A823-4DB4-B7E0-696ED6FA0C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0312" y="568929"/>
            <a:ext cx="6547671" cy="404809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8DA74F4-F921-4C3D-A147-995D702FCE92}"/>
              </a:ext>
            </a:extLst>
          </p:cNvPr>
          <p:cNvSpPr/>
          <p:nvPr/>
        </p:nvSpPr>
        <p:spPr>
          <a:xfrm>
            <a:off x="2290353" y="5167981"/>
            <a:ext cx="6096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erotype O157:H7 (n=101) core SNP based phylogenetic tree generated by Snippy v. 4.6.0 (https://github.com/tseemann/snippy) and recombination removal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bbin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 2.4.1. The resulting recombination free core SNP alignment was used to construct high-resolution phylogeny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tTre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. 2.1.9. An interactive version of the tree is available at </a:t>
            </a:r>
            <a:r>
              <a:rPr lang="en-US" sz="1200" u="sng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microreact.org/project/85VRSrPfG8iQhLJhUzYHuA/56a61920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b-NO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1468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ril Lindbäck</dc:creator>
  <cp:lastModifiedBy>Toril Lindbäck</cp:lastModifiedBy>
  <cp:revision>2</cp:revision>
  <dcterms:created xsi:type="dcterms:W3CDTF">2021-02-17T12:39:38Z</dcterms:created>
  <dcterms:modified xsi:type="dcterms:W3CDTF">2021-02-17T12:5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iteId">
    <vt:lpwstr>eec01f8e-737f-43e3-9ed5-f8a59913bd82</vt:lpwstr>
  </property>
  <property fmtid="{D5CDD505-2E9C-101B-9397-08002B2CF9AE}" pid="4" name="MSIP_Label_d0484126-3486-41a9-802e-7f1e2277276c_Owner">
    <vt:lpwstr>toril.lindback@nmbu.no</vt:lpwstr>
  </property>
  <property fmtid="{D5CDD505-2E9C-101B-9397-08002B2CF9AE}" pid="5" name="MSIP_Label_d0484126-3486-41a9-802e-7f1e2277276c_SetDate">
    <vt:lpwstr>2021-02-17T12:51:43.4698036Z</vt:lpwstr>
  </property>
  <property fmtid="{D5CDD505-2E9C-101B-9397-08002B2CF9AE}" pid="6" name="MSIP_Label_d0484126-3486-41a9-802e-7f1e2277276c_Name">
    <vt:lpwstr>Internal</vt:lpwstr>
  </property>
  <property fmtid="{D5CDD505-2E9C-101B-9397-08002B2CF9AE}" pid="7" name="MSIP_Label_d0484126-3486-41a9-802e-7f1e2277276c_Application">
    <vt:lpwstr>Microsoft Azure Information Protection</vt:lpwstr>
  </property>
  <property fmtid="{D5CDD505-2E9C-101B-9397-08002B2CF9AE}" pid="8" name="MSIP_Label_d0484126-3486-41a9-802e-7f1e2277276c_ActionId">
    <vt:lpwstr>9f7f3b24-b17f-478d-8a9e-15934e53aafc</vt:lpwstr>
  </property>
  <property fmtid="{D5CDD505-2E9C-101B-9397-08002B2CF9AE}" pid="9" name="MSIP_Label_d0484126-3486-41a9-802e-7f1e2277276c_Extended_MSFT_Method">
    <vt:lpwstr>Automatic</vt:lpwstr>
  </property>
  <property fmtid="{D5CDD505-2E9C-101B-9397-08002B2CF9AE}" pid="10" name="Sensitivity">
    <vt:lpwstr>Internal</vt:lpwstr>
  </property>
</Properties>
</file>